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2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0375" y="3331516"/>
            <a:ext cx="1499856" cy="1177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192254" y="-20376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essing the performance of large language models (GPT-3.5 and GPT-4) and accurate clinical information for pediatric nephrology</a:t>
            </a:r>
            <a:endParaRPr lang="en-US" sz="18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92254" y="1016333"/>
            <a:ext cx="119997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is study aimed to evaluate the clinical decision-making performance of two AI-based language models, GPT-3.5 and GPT-4, in pediatric nephrology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Forty pediatric nephrology specialists with ≥5 years of experience rated GPT-3.5</a:t>
            </a:r>
          </a:p>
          <a:p>
            <a:r>
              <a:rPr lang="en-GB" dirty="0">
                <a:solidFill>
                  <a:srgbClr val="0065AA"/>
                </a:solidFill>
              </a:rPr>
              <a:t>and GPT-4 responses to 10 clinical questions using a 1–5 scale via Google Forms. Statistical</a:t>
            </a:r>
          </a:p>
          <a:p>
            <a:r>
              <a:rPr lang="en-GB" dirty="0">
                <a:solidFill>
                  <a:srgbClr val="0065AA"/>
                </a:solidFill>
              </a:rPr>
              <a:t>analyses included independent t-tests, Cronbach’s alpha for reliability, and Cohen’s d for</a:t>
            </a:r>
          </a:p>
          <a:p>
            <a:r>
              <a:rPr lang="en-GB" dirty="0">
                <a:solidFill>
                  <a:srgbClr val="0065AA"/>
                </a:solidFill>
              </a:rPr>
              <a:t>effect size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>
                <a:solidFill>
                  <a:schemeClr val="bg1"/>
                </a:solidFill>
                <a:latin typeface="+mj-lt"/>
              </a:rPr>
              <a:t>Sav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While GPT-3.5 and GPT-4 provided a foundational level of clinical decision support, neither model exhibited superior performance in addressing the unique challenges of pediatric nephrology. 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675" y="3170238"/>
            <a:ext cx="512763" cy="1049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107448" y="317023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750166" y="405083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Metin kutusu 3"/>
          <p:cNvSpPr txBox="1"/>
          <p:nvPr/>
        </p:nvSpPr>
        <p:spPr>
          <a:xfrm>
            <a:off x="21048" y="5169041"/>
            <a:ext cx="3169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dirty="0">
                <a:solidFill>
                  <a:schemeClr val="accent5"/>
                </a:solidFill>
              </a:rPr>
              <a:t>Pediatric nephrology specialists</a:t>
            </a: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92254" y="405083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374148" y="40889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7518" y="3140170"/>
            <a:ext cx="7620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7432" y="4497479"/>
            <a:ext cx="755650" cy="603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Rectangle 58"/>
          <p:cNvSpPr/>
          <p:nvPr/>
        </p:nvSpPr>
        <p:spPr>
          <a:xfrm>
            <a:off x="4845518" y="3653356"/>
            <a:ext cx="1498132" cy="524669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onclusions</a:t>
            </a:r>
            <a:r>
              <a:rPr lang="tr-TR" dirty="0">
                <a:solidFill>
                  <a:srgbClr val="AA0065"/>
                </a:solidFill>
              </a:rPr>
              <a:t>:</a:t>
            </a:r>
            <a:endParaRPr lang="en-GB" dirty="0">
              <a:solidFill>
                <a:srgbClr val="AA0065"/>
              </a:solidFill>
            </a:endParaRPr>
          </a:p>
        </p:txBody>
      </p:sp>
      <p:pic>
        <p:nvPicPr>
          <p:cNvPr id="1034" name="Picture 10" descr="Figure1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1176" y="2652818"/>
            <a:ext cx="4876712" cy="29104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Up Arrow 74"/>
          <p:cNvSpPr/>
          <p:nvPr/>
        </p:nvSpPr>
        <p:spPr>
          <a:xfrm rot="5400000">
            <a:off x="4349544" y="3711511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6465754" y="3627666"/>
            <a:ext cx="323318" cy="5675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409575" y="2848840"/>
            <a:ext cx="11831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n=40</a:t>
            </a:r>
          </a:p>
        </p:txBody>
      </p:sp>
      <p:sp>
        <p:nvSpPr>
          <p:cNvPr id="17" name="Rectangle 48"/>
          <p:cNvSpPr/>
          <p:nvPr/>
        </p:nvSpPr>
        <p:spPr>
          <a:xfrm>
            <a:off x="2559518" y="4477888"/>
            <a:ext cx="1387007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>
                <a:solidFill>
                  <a:schemeClr val="accent5"/>
                </a:solidFill>
              </a:rPr>
              <a:t>GPT-4 </a:t>
            </a:r>
            <a:endParaRPr lang="en-GB" dirty="0">
              <a:solidFill>
                <a:schemeClr val="accent5"/>
              </a:solidFill>
            </a:endParaRPr>
          </a:p>
        </p:txBody>
      </p:sp>
      <p:sp>
        <p:nvSpPr>
          <p:cNvPr id="16" name="Rectangle 19"/>
          <p:cNvSpPr/>
          <p:nvPr/>
        </p:nvSpPr>
        <p:spPr>
          <a:xfrm>
            <a:off x="2421442" y="2741783"/>
            <a:ext cx="1322929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/>
              <a:t>GPT-3.5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3</TotalTime>
  <Words>134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8</cp:revision>
  <dcterms:created xsi:type="dcterms:W3CDTF">2019-06-13T12:30:18Z</dcterms:created>
  <dcterms:modified xsi:type="dcterms:W3CDTF">2025-02-12T22:39:08Z</dcterms:modified>
</cp:coreProperties>
</file>